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6" r:id="rId2"/>
    <p:sldId id="257" r:id="rId3"/>
    <p:sldId id="258" r:id="rId4"/>
    <p:sldId id="259" r:id="rId5"/>
    <p:sldId id="260" r:id="rId6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0282" autoAdjust="0"/>
  </p:normalViewPr>
  <p:slideViewPr>
    <p:cSldViewPr snapToGrid="0">
      <p:cViewPr varScale="1">
        <p:scale>
          <a:sx n="69" d="100"/>
          <a:sy n="69" d="100"/>
        </p:scale>
        <p:origin x="51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F899A5-1B82-4F5A-A777-854035A6BE08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C885B9-96B2-46B6-A62C-23DE1739F0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517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on-priority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C885B9-96B2-46B6-A62C-23DE1739F0E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9918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nderlying medical condi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C885B9-96B2-46B6-A62C-23DE1739F0EA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8581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5 and older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C885B9-96B2-46B6-A62C-23DE1739F0EA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8755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CW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C885B9-96B2-46B6-A62C-23DE1739F0EA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9863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8BA72F-EBFA-4AE0-8301-F69418281A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8B1CBB7-86B7-4D57-8B6F-B8CF138858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D1BE0A-ECB3-4178-A6F7-ABF7D13A1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B3A5B08-26D9-4C40-8117-A60A60A7F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40591A-2D2B-4B9D-B654-0A2B636F3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7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FC302A-EDEB-4309-B208-E3EA138F4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4BBD8BA-417F-497A-B955-C5B16A3E43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4DEC62-F5F6-405D-A86A-623C1ABAD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B8E27C-4969-4A33-B3E1-7F7B94D3F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7CCDC6-F365-498A-91FA-F3177EA51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223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C6540CB-D81C-453B-A103-BE69F0E05E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F8FCD17-3489-406C-982D-7A03CCDA6A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1B6A6A-77AF-4FB8-B122-A868226E0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D5F2E8-DDAE-49FF-ABAC-42F77BECB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300040-9FC9-47D8-B1AC-B2DB0C5A7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4907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39C981-AF21-4C6D-9196-528066C7DC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AE9392-006C-41CA-8040-CF222C7053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F03E76-0C20-4982-9B1E-C8D3F9A87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D42425-72F3-487B-8651-7D5F9F2CA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459338-317B-47E7-9A14-13AFC2163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7962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E1CD5B-C6AC-4B68-9D82-45FA41765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FBF96C-5BD7-4D3B-B52E-61583D38DF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398DF5-64A9-413C-B571-AE79CA390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ABEF68-CAA2-4B5A-B225-E72CF459E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B17696-63EF-4063-8184-E285D129D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0877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13EB6A-7936-48EF-B739-0B5F86712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78C0093-F3CB-465C-9F56-0E39DD9CAB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E03939D-BD62-4C2D-9C20-B6DD760938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8DA507-A9F4-46D2-AD8D-1EA8B294B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29FD70D-D31D-41C0-941A-0BCF42685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9DD3DC4-EEBA-43C0-A8F9-62FF5917C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989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C16727-4885-4E33-A4DA-876775CA6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6079C26-2DFE-446E-B87A-67C7741599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6682105-9D61-46FF-B1EF-133696EB8F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EC10B04-DB5E-49F5-A65D-69F8255BA0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419E176-805F-485D-89EF-34BC4BE428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A7061C9-170B-4324-B5E1-7D0BD5A79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698EB26-2042-4898-836A-9E94A8D25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77EF066-C60A-4DED-AA2E-12FA3E49E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192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237213-E91A-45DF-AAD5-C1DFF5FED4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E459FA0-291C-4B22-8863-F03483638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8C648A2-1EBE-4527-B840-936B13A44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D572A18-2492-43DA-8D23-23D6345C2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88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E9226C8-90AE-46E3-ADC8-348DDDB3F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56C5F13-329C-4A77-A142-3BB090EAC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5320893-BFB1-4EB4-9010-14253E4B9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170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114C65-E20B-46A1-9436-0AB11D51B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960ABF-EF6C-453B-91A7-C65F86393F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9E87716-3E69-4928-804C-E0D8BB747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D731490-2B36-4D1E-81D1-059336BC4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C98D448-20F1-44FF-ACE9-5653A01BC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961383-0331-473F-B032-60A0B3379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787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5EE9AA-973A-41B3-8D99-3106E5F0F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AC933A7-C004-41AE-A8F1-4F2A14E4DB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41A48CC-EDA8-4458-BDFD-67B21B3706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BEEC24B-1D43-441C-9EAC-6614EC648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97685B-ACCB-4E32-97E8-55CB095F5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36095AF-D3EB-4207-9028-9970D2FD7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839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8321CF5-4C78-406D-9488-868EC9B16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267AEBD-089F-4112-A6F3-EA915F83DA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E69766-A70E-40EF-96A4-D26F1E5F48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A000B-EB38-43CB-A0E3-3008787AD5B1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396EED-D796-407E-A1F9-64744AE2AF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4A6973-F592-471E-9CCC-AE5D40C8CC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7369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4E77537-863A-2834-892E-1A33EAFB816D}"/>
              </a:ext>
            </a:extLst>
          </p:cNvPr>
          <p:cNvSpPr txBox="1"/>
          <p:nvPr/>
        </p:nvSpPr>
        <p:spPr>
          <a:xfrm>
            <a:off x="2904344" y="1399987"/>
            <a:ext cx="6383311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dirty="0">
                <a:latin typeface="Cambria" panose="02040503050406030204" pitchFamily="18" charset="0"/>
                <a:ea typeface="Cambria" panose="02040503050406030204" pitchFamily="18" charset="0"/>
              </a:rPr>
              <a:t>This is a Multimedia Appendix to a full manuscript published in the J Med Internet Res. </a:t>
            </a:r>
          </a:p>
          <a:p>
            <a:pPr algn="ctr"/>
            <a:r>
              <a:rPr lang="en-US" altLang="ja-JP" sz="2400" dirty="0">
                <a:latin typeface="Cambria" panose="02040503050406030204" pitchFamily="18" charset="0"/>
                <a:ea typeface="Cambria" panose="02040503050406030204" pitchFamily="18" charset="0"/>
              </a:rPr>
              <a:t>For full copyright and citation information see http://dx.doi.org</a:t>
            </a:r>
            <a:r>
              <a:rPr lang="en-US" altLang="ja-JP" sz="2400">
                <a:latin typeface="Cambria" panose="02040503050406030204" pitchFamily="18" charset="0"/>
                <a:ea typeface="Cambria" panose="02040503050406030204" pitchFamily="18" charset="0"/>
              </a:rPr>
              <a:t>/10.2196/42143</a:t>
            </a:r>
            <a:endParaRPr lang="ja-JP" altLang="en-US" sz="2400" dirty="0">
              <a:latin typeface="Cambria" panose="020405030504060302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D2F13FC-E63D-4EEE-A261-2210BFADF757}"/>
              </a:ext>
            </a:extLst>
          </p:cNvPr>
          <p:cNvSpPr txBox="1"/>
          <p:nvPr/>
        </p:nvSpPr>
        <p:spPr>
          <a:xfrm>
            <a:off x="1795206" y="3429000"/>
            <a:ext cx="8601585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dirty="0">
                <a:latin typeface="Cambria" panose="02040503050406030204" pitchFamily="18" charset="0"/>
                <a:ea typeface="Cambria" panose="02040503050406030204" pitchFamily="18" charset="0"/>
              </a:rPr>
              <a:t>Shift in reason for not getting vaccinated against COVID-19 from February 2021 to February 2022, stratified by the nonpriority group and the 3 priority groups. </a:t>
            </a:r>
          </a:p>
          <a:p>
            <a:pPr algn="ctr"/>
            <a:endParaRPr lang="en-US" altLang="ja-JP" sz="2400" dirty="0"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algn="ctr"/>
            <a:r>
              <a:rPr lang="en-US" altLang="ja-JP" dirty="0">
                <a:latin typeface="Cambria" panose="02040503050406030204" pitchFamily="18" charset="0"/>
                <a:ea typeface="Cambria" panose="02040503050406030204" pitchFamily="18" charset="0"/>
              </a:rPr>
              <a:t>Respondents were those who chose to wait and see or refused to receive the vaccines at each time point. The following sentences was asked only at T2 and T3: “Long-term side effects are unknown,” “I’m worry about short term side effects,” “I’m worried about death by the vaccines,” and “I don’t trust the vaccines’ approval process.”</a:t>
            </a:r>
          </a:p>
        </p:txBody>
      </p:sp>
    </p:spTree>
    <p:extLst>
      <p:ext uri="{BB962C8B-B14F-4D97-AF65-F5344CB8AC3E}">
        <p14:creationId xmlns:p14="http://schemas.microsoft.com/office/powerpoint/2010/main" val="941283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007BC45-9208-ED58-C7EB-9C43EC2A01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49388"/>
            <a:ext cx="12192000" cy="6359223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207736E-D010-807D-ECED-2D871B0A26F3}"/>
              </a:ext>
            </a:extLst>
          </p:cNvPr>
          <p:cNvSpPr txBox="1"/>
          <p:nvPr/>
        </p:nvSpPr>
        <p:spPr>
          <a:xfrm>
            <a:off x="156086" y="6423945"/>
            <a:ext cx="11879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S1. Nonpriority group (n=7017)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495ED64-BF36-FE5C-DE48-7DBC48267FAC}"/>
              </a:ext>
            </a:extLst>
          </p:cNvPr>
          <p:cNvSpPr txBox="1"/>
          <p:nvPr/>
        </p:nvSpPr>
        <p:spPr>
          <a:xfrm>
            <a:off x="11561196" y="305486"/>
            <a:ext cx="5859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(%)</a:t>
            </a:r>
            <a:endParaRPr kumimoji="1" lang="ja-JP" altLang="en-US" sz="1600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93034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B5DC778-B466-76DB-B1A3-8A3A7C1C66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49388"/>
            <a:ext cx="12192000" cy="6359223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55D9CED-7420-36B2-F101-5D9C42AF4023}"/>
              </a:ext>
            </a:extLst>
          </p:cNvPr>
          <p:cNvSpPr txBox="1"/>
          <p:nvPr/>
        </p:nvSpPr>
        <p:spPr>
          <a:xfrm>
            <a:off x="156086" y="6423945"/>
            <a:ext cx="11879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S2. Priority group of 18-64 years with pre-existing conditions, non-health</a:t>
            </a:r>
            <a:r>
              <a:rPr lang="ja-JP" altLang="en-US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care worker (n=1659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155FA34-A102-EC70-5C17-97FD04D88800}"/>
              </a:ext>
            </a:extLst>
          </p:cNvPr>
          <p:cNvSpPr txBox="1"/>
          <p:nvPr/>
        </p:nvSpPr>
        <p:spPr>
          <a:xfrm>
            <a:off x="11561196" y="305486"/>
            <a:ext cx="5859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(%)</a:t>
            </a:r>
            <a:endParaRPr kumimoji="1" lang="ja-JP" altLang="en-US" sz="1600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3379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251EDED-EFD8-D57F-5E54-EB533FF5AB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47827"/>
            <a:ext cx="12192000" cy="6362345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2D44662-ACC7-C6FE-5610-89C5E1E32C0B}"/>
              </a:ext>
            </a:extLst>
          </p:cNvPr>
          <p:cNvSpPr txBox="1"/>
          <p:nvPr/>
        </p:nvSpPr>
        <p:spPr>
          <a:xfrm>
            <a:off x="156086" y="6425506"/>
            <a:ext cx="11879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S3. Priority group of </a:t>
            </a:r>
            <a:r>
              <a:rPr lang="en-US" altLang="ja-JP" sz="1800" dirty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≥</a:t>
            </a:r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65 years, non-health care worker (n=4048)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22DC04B-FF23-41C5-C012-EF3307D0A808}"/>
              </a:ext>
            </a:extLst>
          </p:cNvPr>
          <p:cNvSpPr txBox="1"/>
          <p:nvPr/>
        </p:nvSpPr>
        <p:spPr>
          <a:xfrm>
            <a:off x="11561196" y="305486"/>
            <a:ext cx="5859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(%)</a:t>
            </a:r>
            <a:endParaRPr kumimoji="1" lang="ja-JP" altLang="en-US" sz="1600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94556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29330D5-354F-4573-E9F0-BE8336A06B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47827"/>
            <a:ext cx="12192000" cy="6362345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A906BA2-534C-9ED7-EF43-0ACE57876E19}"/>
              </a:ext>
            </a:extLst>
          </p:cNvPr>
          <p:cNvSpPr txBox="1"/>
          <p:nvPr/>
        </p:nvSpPr>
        <p:spPr>
          <a:xfrm>
            <a:off x="156086" y="6425506"/>
            <a:ext cx="11879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S4. </a:t>
            </a:r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Priority group of health care worker (n=831)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E0FDF8B-DCB8-8CE6-562F-16013F468E20}"/>
              </a:ext>
            </a:extLst>
          </p:cNvPr>
          <p:cNvSpPr txBox="1"/>
          <p:nvPr/>
        </p:nvSpPr>
        <p:spPr>
          <a:xfrm>
            <a:off x="11561196" y="305486"/>
            <a:ext cx="5859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(%)</a:t>
            </a:r>
            <a:endParaRPr kumimoji="1" lang="ja-JP" altLang="en-US" sz="1600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0193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7</TotalTime>
  <Words>205</Words>
  <Application>Microsoft Office PowerPoint</Application>
  <PresentationFormat>ワイド画面</PresentationFormat>
  <Paragraphs>21</Paragraphs>
  <Slides>5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游ゴシック Light</vt:lpstr>
      <vt:lpstr>Arial</vt:lpstr>
      <vt:lpstr>Cambri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橋司</dc:creator>
  <cp:lastModifiedBy>大介 堀</cp:lastModifiedBy>
  <cp:revision>60</cp:revision>
  <cp:lastPrinted>2022-04-25T06:11:55Z</cp:lastPrinted>
  <dcterms:created xsi:type="dcterms:W3CDTF">2022-04-18T10:20:13Z</dcterms:created>
  <dcterms:modified xsi:type="dcterms:W3CDTF">2023-06-30T03:48:21Z</dcterms:modified>
</cp:coreProperties>
</file>